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3" r:id="rId2"/>
    <p:sldId id="282" r:id="rId3"/>
    <p:sldId id="268" r:id="rId4"/>
    <p:sldId id="262" r:id="rId5"/>
    <p:sldId id="263" r:id="rId6"/>
    <p:sldId id="281" r:id="rId7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4660"/>
  </p:normalViewPr>
  <p:slideViewPr>
    <p:cSldViewPr snapToGrid="0">
      <p:cViewPr varScale="1">
        <p:scale>
          <a:sx n="110" d="100"/>
          <a:sy n="110" d="100"/>
        </p:scale>
        <p:origin x="51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D6D8B6-2594-CE26-AC7A-B289EB6B31D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7E46781-1766-77A5-B793-78CCBB8B80B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ko-KR"/>
              <a:t>Click to edit Master subtitle style</a:t>
            </a:r>
            <a:endParaRPr lang="ko-KR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C8C5F1-C7C6-BAC0-D82E-A1D135AB84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97D6B-0FD1-4F3F-9AF2-771424694184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01899D-2EBC-0E19-6886-3B3FD26456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3A7007-2B73-A65C-376E-1808D97BE4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5FC72-8669-4D79-A25E-3C3592F803F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340404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3ABE61-2830-3914-C0CB-E199803D84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BDE1C94-32C6-1001-7A60-AEA8E29877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5FF62F-172E-FAA4-6912-1FF2104D31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97D6B-0FD1-4F3F-9AF2-771424694184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C0286A-5B2D-4423-8BF7-7FD0365640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ECB20D-6EC9-D8CA-0E7E-40B884E115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5FC72-8669-4D79-A25E-3C3592F803F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479782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F5CDD78-10FF-CA27-0E99-97BBFEF5AE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7363F9-3C51-15A5-11E9-D58E9A9A71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1BEB5D-2BA8-450D-C7B2-139A5AB411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97D6B-0FD1-4F3F-9AF2-771424694184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D386AB-8255-6194-A7F4-6D5E683E3B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647B37-6F12-ADDC-0CA0-2F3A450983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5FC72-8669-4D79-A25E-3C3592F803F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43694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DF22F6-FA3C-DA15-92AE-651654C089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49D9A8-EA14-ADE0-EA3B-342B4A1F432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FDADF9-2F54-C886-EC64-94C706340B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97D6B-0FD1-4F3F-9AF2-771424694184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F0412F-BB2F-48C7-1F3B-68900E6383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9E718B-0F58-6D7E-558C-959772A08F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5FC72-8669-4D79-A25E-3C3592F803F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83986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5BC089-6EC0-4C4E-18D1-D47AFB3247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21DEFB-EA5C-94AE-6B82-A8E0A1E03B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FCA6DC-5393-DEB7-86B4-91A0D81BEE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97D6B-0FD1-4F3F-9AF2-771424694184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07DE9B-1F60-BDC7-4B8A-BBEE701AAE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070813-46D0-10DE-E8ED-255F81D40E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5FC72-8669-4D79-A25E-3C3592F803F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7552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79656B-646B-9CD3-25FC-C4B8316255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7270A2-965F-AB99-BF81-5751343693B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4A440EF-C7CD-E113-1DDC-F89A77924F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BF732D-676A-0430-5CE2-8070455450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97D6B-0FD1-4F3F-9AF2-771424694184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31D240-AD05-40AE-CACD-3F8B35F613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39FBD7-843F-BBFC-418B-6187D3C5E5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5FC72-8669-4D79-A25E-3C3592F803F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9757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D4AEDA-7CD2-0A90-52C3-26C2FDB251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0210DB4-4D41-F461-2A66-298153F1DA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8C1DD0F-0B08-EDAE-A65F-B7B89DD051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CE17FA5-C151-2B3F-1101-F87B0E357D4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FD853C7-E0DD-D8B8-8466-02B6A649C5E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D08BACF-C7F1-2E1A-56C9-79DBD7ABF4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97D6B-0FD1-4F3F-9AF2-771424694184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40E5CEA-4FA3-4B9E-9D19-D9F261E207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4722941-4D9A-9801-648C-C7C9E0253C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5FC72-8669-4D79-A25E-3C3592F803F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539534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E26430-8DBF-B82C-BC65-3CC381249F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703AAA5-6CCC-F7BF-6DA6-044D9A0176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97D6B-0FD1-4F3F-9AF2-771424694184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4028A08-7F98-FF9E-2DC8-2E2F8670F6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CD3FA6B-455A-4DEC-CB43-45E78C977E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5FC72-8669-4D79-A25E-3C3592F803F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733678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D70F75C-D522-33F0-E780-BF9F4DA4AC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97D6B-0FD1-4F3F-9AF2-771424694184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C84B53F-7278-1469-8F07-FDBB4A60EA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2A71178-7D3A-377E-4B8C-268E96695D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5FC72-8669-4D79-A25E-3C3592F803F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1709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2C1262-77BD-15C1-FCF4-4490C72D2A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4D6B8D-1A9F-A9F2-2CD7-3DF109115DF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3B5026B-3AFE-49FE-612D-B9E3D605BC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6852CA-66D4-5466-77FD-FE971F09D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97D6B-0FD1-4F3F-9AF2-771424694184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1BD38B-E75D-8A9D-065B-A3015578CC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F34063-33CB-B399-A952-5EA8D9A428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5FC72-8669-4D79-A25E-3C3592F803F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201078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ED65AE-8FA0-ABA0-C2D9-6547E6EB14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4E5B27A-1E89-6448-54B2-7C17053B957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A0298E-48DD-C9E9-98A4-39D767B309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87EB59-F68B-2F19-1553-84DFA33840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97D6B-0FD1-4F3F-9AF2-771424694184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40B950-18D4-7756-F2BA-A316938F85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0C3184-C8C4-E43B-E255-F9B7D53D79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5FC72-8669-4D79-A25E-3C3592F803F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050852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900E7EE-0D00-A517-9228-9A8DC87FE1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FA72F2-6063-CCD0-ED68-10137ECF99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6B3652-8327-2764-03F1-FC1C2EB425E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397D6B-0FD1-4F3F-9AF2-771424694184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8375CF-1FA5-A389-E3E2-796ABE032CD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2FB678-3EBD-2DF6-3757-FF62156D0A3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55FC72-8669-4D79-A25E-3C3592F803F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472173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63751D1-7614-DC04-93B1-D124AF2627E8}"/>
              </a:ext>
            </a:extLst>
          </p:cNvPr>
          <p:cNvSpPr txBox="1">
            <a:spLocks noGrp="1" noRot="1" noMove="1" noResize="1" noEditPoints="1" noAdjustHandles="1" noChangeArrowheads="1" noChangeShapeType="1"/>
          </p:cNvSpPr>
          <p:nvPr/>
        </p:nvSpPr>
        <p:spPr>
          <a:xfrm>
            <a:off x="0" y="6519446"/>
            <a:ext cx="151967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vi-VN" altLang="ko-KR" sz="16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altLang="ko-KR" sz="16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vi-VN" altLang="ko-KR" sz="16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 descr="A close up of a document&#10;&#10;Description automatically generated">
            <a:extLst>
              <a:ext uri="{FF2B5EF4-FFF2-40B4-BE49-F238E27FC236}">
                <a16:creationId xmlns:a16="http://schemas.microsoft.com/office/drawing/2014/main" id="{2C1B64E6-8090-74D1-9300-3CCFCDE89EE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74" t="22269" r="23305" b="21277"/>
          <a:stretch/>
        </p:blipFill>
        <p:spPr>
          <a:xfrm>
            <a:off x="1981200" y="327314"/>
            <a:ext cx="8229600" cy="62033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3594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F9C07A57-6D6D-61BB-CBCC-C347D7909A75}"/>
              </a:ext>
            </a:extLst>
          </p:cNvPr>
          <p:cNvSpPr txBox="1"/>
          <p:nvPr/>
        </p:nvSpPr>
        <p:spPr>
          <a:xfrm>
            <a:off x="0" y="6519446"/>
            <a:ext cx="151967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vi-VN" altLang="ko-KR" sz="16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altLang="ko-KR" sz="16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vi-VN" altLang="ko-KR" sz="16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 descr="A screenshot of a computer&#10;&#10;Description automatically generated">
            <a:extLst>
              <a:ext uri="{FF2B5EF4-FFF2-40B4-BE49-F238E27FC236}">
                <a16:creationId xmlns:a16="http://schemas.microsoft.com/office/drawing/2014/main" id="{1B044EC7-CB99-87E7-7D6D-C2C1BA43DB0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575" t="21559" r="24708" b="21277"/>
          <a:stretch/>
        </p:blipFill>
        <p:spPr>
          <a:xfrm>
            <a:off x="1981200" y="151799"/>
            <a:ext cx="8229600" cy="65544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030868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63751D1-7614-DC04-93B1-D124AF2627E8}"/>
              </a:ext>
            </a:extLst>
          </p:cNvPr>
          <p:cNvSpPr txBox="1"/>
          <p:nvPr/>
        </p:nvSpPr>
        <p:spPr>
          <a:xfrm>
            <a:off x="0" y="6519446"/>
            <a:ext cx="151967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vi-VN" altLang="ko-KR" sz="16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altLang="ko-KR" sz="16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vi-VN" altLang="ko-KR" sz="16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 descr="A diagram of a number of points&#10;&#10;Description automatically generated with medium confidence">
            <a:extLst>
              <a:ext uri="{FF2B5EF4-FFF2-40B4-BE49-F238E27FC236}">
                <a16:creationId xmlns:a16="http://schemas.microsoft.com/office/drawing/2014/main" id="{B856669D-C950-F101-7064-44238B7DD21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3158" y="0"/>
            <a:ext cx="896568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364907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161F8CF7-24CC-7ABB-97A2-B6A3FD203CF2}"/>
              </a:ext>
            </a:extLst>
          </p:cNvPr>
          <p:cNvSpPr txBox="1"/>
          <p:nvPr/>
        </p:nvSpPr>
        <p:spPr>
          <a:xfrm>
            <a:off x="0" y="6519446"/>
            <a:ext cx="151967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vi-VN" altLang="ko-KR" sz="16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altLang="ko-KR" sz="16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vi-VN" altLang="ko-KR" sz="16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 descr="A graph with dots and lines&#10;&#10;Description automatically generated">
            <a:extLst>
              <a:ext uri="{FF2B5EF4-FFF2-40B4-BE49-F238E27FC236}">
                <a16:creationId xmlns:a16="http://schemas.microsoft.com/office/drawing/2014/main" id="{4E44AA37-C41C-3A63-03C1-38225D5F17E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0813" y="0"/>
            <a:ext cx="961037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01838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with a line and dots&#10;&#10;Description automatically generated with medium confidence">
            <a:extLst>
              <a:ext uri="{FF2B5EF4-FFF2-40B4-BE49-F238E27FC236}">
                <a16:creationId xmlns:a16="http://schemas.microsoft.com/office/drawing/2014/main" id="{9FF891F2-C121-E42A-6DC8-2CA30F26532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3158" y="0"/>
            <a:ext cx="8965685" cy="6858000"/>
          </a:xfrm>
          <a:prstGeom prst="rect">
            <a:avLst/>
          </a:prstGeom>
        </p:spPr>
      </p:pic>
      <p:sp>
        <p:nvSpPr>
          <p:cNvPr id="6" name="Rectangle 2">
            <a:extLst>
              <a:ext uri="{FF2B5EF4-FFF2-40B4-BE49-F238E27FC236}">
                <a16:creationId xmlns:a16="http://schemas.microsoft.com/office/drawing/2014/main" id="{C38E14D4-2A66-1751-F8A1-202C2D3899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32299" y="3387458"/>
            <a:ext cx="4681481" cy="1800493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Linear regression test of funnel plot asymmetry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ko-KR" sz="9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Lucida Console" panose="020B06090405040202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Test result: t = 0.41, </a:t>
            </a:r>
            <a:r>
              <a:rPr kumimoji="0" lang="en-US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df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 = 23, p-value = 0.6874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ko-KR" sz="9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Lucida Console" panose="020B06090405040202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Sample estimates: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   bias </a:t>
            </a:r>
            <a:r>
              <a:rPr kumimoji="0" lang="en-US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se.bias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 intercept </a:t>
            </a:r>
            <a:r>
              <a:rPr kumimoji="0" lang="en-US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se.intercept</a:t>
            </a:r>
            <a:endParaRPr kumimoji="0" lang="en-US" altLang="ko-KR" sz="9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Lucida Console" panose="020B06090405040202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 1.3415  3.2915   -2.9452       0.2989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ko-KR" sz="9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Lucida Console" panose="020B06090405040202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Details: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- multiplicative residual heterogeneity variance (tau^2 = 147.5567)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- predictor: standard error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- weight:    inverse variance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- reference: Egger et al. (1997), BMJ</a:t>
            </a:r>
            <a:endParaRPr kumimoji="0" lang="ko-KR" altLang="ko-K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F998D84-2432-A71D-DFE2-38B69FEF79B8}"/>
              </a:ext>
            </a:extLst>
          </p:cNvPr>
          <p:cNvSpPr txBox="1"/>
          <p:nvPr/>
        </p:nvSpPr>
        <p:spPr>
          <a:xfrm>
            <a:off x="0" y="6519446"/>
            <a:ext cx="151967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vi-VN" altLang="ko-KR" sz="16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altLang="ko-KR" sz="16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vi-VN" altLang="ko-KR" sz="16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74798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aph with numbers and points&#10;&#10;Description automatically generated">
            <a:extLst>
              <a:ext uri="{FF2B5EF4-FFF2-40B4-BE49-F238E27FC236}">
                <a16:creationId xmlns:a16="http://schemas.microsoft.com/office/drawing/2014/main" id="{C3570CEE-A9FC-DAD4-46FB-BBD91161DFF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0813" y="0"/>
            <a:ext cx="9610375" cy="6858000"/>
          </a:xfrm>
          <a:prstGeom prst="rect">
            <a:avLst/>
          </a:prstGeom>
        </p:spPr>
      </p:pic>
      <p:sp>
        <p:nvSpPr>
          <p:cNvPr id="6" name="Rectangle 2">
            <a:extLst>
              <a:ext uri="{FF2B5EF4-FFF2-40B4-BE49-F238E27FC236}">
                <a16:creationId xmlns:a16="http://schemas.microsoft.com/office/drawing/2014/main" id="{C38E14D4-2A66-1751-F8A1-202C2D3899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28996" y="1259791"/>
            <a:ext cx="4792824" cy="1800493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Linear regression test of funnel plot asymmetry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ko-KR" sz="9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Lucida Console" panose="020B06090405040202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Test result: t = 0.42, </a:t>
            </a:r>
            <a:r>
              <a:rPr kumimoji="0" lang="en-US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df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 = 17, p-value = 0.6809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ko-KR" sz="9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Lucida Console" panose="020B06090405040202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Sample estimates: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   bias </a:t>
            </a:r>
            <a:r>
              <a:rPr kumimoji="0" lang="en-US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se.bias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 intercept </a:t>
            </a:r>
            <a:r>
              <a:rPr kumimoji="0" lang="en-US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se.intercept</a:t>
            </a:r>
            <a:endParaRPr kumimoji="0" lang="en-US" altLang="ko-KR" sz="9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Lucida Console" panose="020B06090405040202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 0.8942  2.1372    0.6829       0.4055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ko-KR" sz="9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Lucida Console" panose="020B06090405040202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Details: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- multiplicative residual heterogeneity variance (tau^2 = 41.5283)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- predictor: standard error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- weight:    inverse variance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Lucida Console" panose="020B0609040504020204" pitchFamily="49" charset="0"/>
              </a:rPr>
              <a:t>- reference: Egger et al. (1997), BMJ</a:t>
            </a:r>
            <a:endParaRPr kumimoji="0" lang="ko-KR" altLang="ko-K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068E952-C5D4-4CD9-1F76-DE9A68049F6F}"/>
              </a:ext>
            </a:extLst>
          </p:cNvPr>
          <p:cNvSpPr txBox="1"/>
          <p:nvPr/>
        </p:nvSpPr>
        <p:spPr>
          <a:xfrm>
            <a:off x="0" y="6519446"/>
            <a:ext cx="151967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vi-VN" altLang="ko-KR" sz="16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altLang="ko-KR" sz="16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vi-VN" altLang="ko-KR" sz="16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97031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34</TotalTime>
  <Words>165</Words>
  <Application>Microsoft Office PowerPoint</Application>
  <PresentationFormat>와이드스크린</PresentationFormat>
  <Paragraphs>32</Paragraphs>
  <Slides>6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10" baseType="lpstr">
      <vt:lpstr>맑은 고딕</vt:lpstr>
      <vt:lpstr>Arial</vt:lpstr>
      <vt:lpstr>Lucida Console</vt:lpstr>
      <vt:lpstr>Office Theme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긴호앙롱</dc:creator>
  <cp:lastModifiedBy>user</cp:lastModifiedBy>
  <cp:revision>4</cp:revision>
  <dcterms:created xsi:type="dcterms:W3CDTF">2023-02-16T07:15:51Z</dcterms:created>
  <dcterms:modified xsi:type="dcterms:W3CDTF">2024-04-16T08:26:41Z</dcterms:modified>
</cp:coreProperties>
</file>